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notesMasterIdLst>
    <p:notesMasterId r:id="rId6"/>
  </p:notesMasterIdLst>
  <p:sldIdLst>
    <p:sldId id="274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40"/>
    <p:restoredTop sz="94643"/>
  </p:normalViewPr>
  <p:slideViewPr>
    <p:cSldViewPr snapToGrid="0">
      <p:cViewPr varScale="1">
        <p:scale>
          <a:sx n="68" d="100"/>
          <a:sy n="68" d="100"/>
        </p:scale>
        <p:origin x="524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oAnn Clair" userId="660c3bf8-b8f8-4e43-a5c2-c4b92a298dab" providerId="ADAL" clId="{DBA0F72B-B1AF-48CF-BDFA-A9CDD94EBFBA}"/>
    <pc:docChg chg="modSld">
      <pc:chgData name="JoAnn Clair" userId="660c3bf8-b8f8-4e43-a5c2-c4b92a298dab" providerId="ADAL" clId="{DBA0F72B-B1AF-48CF-BDFA-A9CDD94EBFBA}" dt="2025-05-15T14:41:42.277" v="1" actId="20577"/>
      <pc:docMkLst>
        <pc:docMk/>
      </pc:docMkLst>
      <pc:sldChg chg="modSp mod">
        <pc:chgData name="JoAnn Clair" userId="660c3bf8-b8f8-4e43-a5c2-c4b92a298dab" providerId="ADAL" clId="{DBA0F72B-B1AF-48CF-BDFA-A9CDD94EBFBA}" dt="2025-05-15T14:41:42.277" v="1" actId="20577"/>
        <pc:sldMkLst>
          <pc:docMk/>
          <pc:sldMk cId="2336959506" sldId="274"/>
        </pc:sldMkLst>
        <pc:spChg chg="mod">
          <ac:chgData name="JoAnn Clair" userId="660c3bf8-b8f8-4e43-a5c2-c4b92a298dab" providerId="ADAL" clId="{DBA0F72B-B1AF-48CF-BDFA-A9CDD94EBFBA}" dt="2025-05-15T14:41:42.277" v="1" actId="20577"/>
          <ac:spMkLst>
            <pc:docMk/>
            <pc:sldMk cId="2336959506" sldId="274"/>
            <ac:spMk id="6" creationId="{E7FA0514-FF64-935B-2B2C-2EDFEE81CED8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812544B-A6F2-1F4B-8F86-13E973054863}" type="datetimeFigureOut">
              <a:rPr lang="en-US" smtClean="0"/>
              <a:t>5/15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5F396AC-7941-C748-ADB9-D714A50D65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92228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279498-D31F-F758-05CB-A6E22908D6E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B4CB30F-85D3-2921-6EFE-63A85F922BE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51C6B1-55FD-2AD1-2721-73A54454F9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C941D-F639-544D-830B-B13D7D2966E3}" type="datetimeFigureOut">
              <a:rPr lang="en-US" smtClean="0"/>
              <a:t>5/1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F5AF32-1C79-69A7-D0EE-C86FE3E1D1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B2C8F4-A3B7-7466-8F04-50B5F0885C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C218F-6715-284F-96B6-CB8B5DAF4E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10856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61CCEA-7D89-ADC4-AF2C-8A30A70AE0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2BB69CA-6A0A-38C0-44E0-6EF2A2B3B16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B478AA-E1A8-D44E-68B5-D10915C741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C941D-F639-544D-830B-B13D7D2966E3}" type="datetimeFigureOut">
              <a:rPr lang="en-US" smtClean="0"/>
              <a:t>5/1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5C0405-765C-A27D-FD41-539798176F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ACC667-4EC5-C7A3-B30B-D09981A29C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C218F-6715-284F-96B6-CB8B5DAF4E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84823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B88B358-B87E-E32B-6E48-FD010157EAE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17C867A-DE94-93B4-6C65-8D69DEB7DCB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5A31E1-D246-AB38-AF22-95D2267131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C941D-F639-544D-830B-B13D7D2966E3}" type="datetimeFigureOut">
              <a:rPr lang="en-US" smtClean="0"/>
              <a:t>5/1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6809E8-922F-9AD4-01D2-B5374BAF34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EFC6A7-632A-E7A3-F4AE-25FA3424EB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C218F-6715-284F-96B6-CB8B5DAF4E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07101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C0C5D0-57CE-7D58-D292-3EEA76E926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2A8E1E0-208B-9446-5BAC-7F7BCAE9F83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450727-5171-866F-51E2-A85EF49112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C941D-F639-544D-830B-B13D7D2966E3}" type="datetimeFigureOut">
              <a:rPr lang="en-US" smtClean="0"/>
              <a:t>5/1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35C5A3-63EC-9BD3-43EF-E7C4BC8CA6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99CC52-108A-955A-EB51-351C352931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C218F-6715-284F-96B6-CB8B5DAF4E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41231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50CADB-D0EA-C104-3C60-F12371F3FA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99E59C8-AFC8-15CA-6D6C-2B9A4B899C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BA1384-F098-2417-11C9-5027759854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C941D-F639-544D-830B-B13D7D2966E3}" type="datetimeFigureOut">
              <a:rPr lang="en-US" smtClean="0"/>
              <a:t>5/1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B48F47-E5A9-E723-3E86-7F470931E9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791CA7-2772-CAE5-B49E-D00FF11CCF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C218F-6715-284F-96B6-CB8B5DAF4E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3634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920A7F-2B7F-BF6F-271D-4A1934ECF2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8D6F1CA-4E89-EF36-CC82-111CE0FCAF2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99C4AD5-F7A7-0100-FB10-350AD31A71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4923709-2403-A360-DFE1-3CFB4955C4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C941D-F639-544D-830B-B13D7D2966E3}" type="datetimeFigureOut">
              <a:rPr lang="en-US" smtClean="0"/>
              <a:t>5/1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4CC7687-D011-A6AA-CCCD-9AF534926B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81FA1FA-5266-D085-D8D7-D255C18043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C218F-6715-284F-96B6-CB8B5DAF4E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47469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A3F355-6BEF-CA03-0F48-477AC4C719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B902DBB-0291-C48C-9432-3E47B4A2E6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7B2E92E-EEBC-58AE-6086-3133CF7CA62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DA68868-64D6-A4A4-131D-3FDA4B527BC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3595EE1-CC0D-73D7-2D81-45ABFD248D1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199AF04-BE69-D741-8391-5726BD44A9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C941D-F639-544D-830B-B13D7D2966E3}" type="datetimeFigureOut">
              <a:rPr lang="en-US" smtClean="0"/>
              <a:t>5/15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8D98E95-0C52-16C9-0071-5FF4143C6B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CD04686-2EDF-952F-5367-9F73A91D98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C218F-6715-284F-96B6-CB8B5DAF4E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21126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045017-1B50-0AD6-42EB-D9F8990714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69C793E-6733-F8DA-E035-454FFB9CB6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C941D-F639-544D-830B-B13D7D2966E3}" type="datetimeFigureOut">
              <a:rPr lang="en-US" smtClean="0"/>
              <a:t>5/15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6D6A689-9A8C-85E0-B8E3-27C530DB8B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45EFF38-3E42-4508-336C-16619048FD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C218F-6715-284F-96B6-CB8B5DAF4E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39444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6D48CDB-0542-6A9F-DA38-A77E7854D5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C941D-F639-544D-830B-B13D7D2966E3}" type="datetimeFigureOut">
              <a:rPr lang="en-US" smtClean="0"/>
              <a:t>5/15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5F90CA6-1974-5C60-93D7-1A01192FA8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A23A7A4-DE28-5AE5-2260-8E86771EBF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C218F-6715-284F-96B6-CB8B5DAF4E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86186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623347-6552-3127-2217-49CC8B3180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74467FA-4EE8-BF89-7FBD-E4D559980DD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945F8B4-94A6-8DF0-DC76-0D106D56B4F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F3C6296-8941-B7A1-3844-0C3061675A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C941D-F639-544D-830B-B13D7D2966E3}" type="datetimeFigureOut">
              <a:rPr lang="en-US" smtClean="0"/>
              <a:t>5/1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038C1E9-A1CE-0C6F-EE19-4EAB151DDE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F87B011-7973-86F0-C670-5922316177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C218F-6715-284F-96B6-CB8B5DAF4E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84940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2DE216-9B04-93E9-2BE6-2DE0133F85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54FF562-77F6-59E8-0286-7069D2180D1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2F3BA97-0BEE-607C-3ED9-B652B68E25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628BEAB-D618-2172-DAF0-862EB148EB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C941D-F639-544D-830B-B13D7D2966E3}" type="datetimeFigureOut">
              <a:rPr lang="en-US" smtClean="0"/>
              <a:t>5/1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96623EE-BC6A-8C35-A4DC-57C0AA76A8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4B7CC09-3C13-BECF-D4B4-C35BF4AF70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C218F-6715-284F-96B6-CB8B5DAF4E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31916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EF674F9-5395-C8B0-67B7-F97957AD22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70E98DF-7876-74F4-4787-ABCCC5A2D3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1BB59CA-522A-B345-5F05-F7E8DDA5478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4C941D-F639-544D-830B-B13D7D2966E3}" type="datetimeFigureOut">
              <a:rPr lang="en-US" smtClean="0"/>
              <a:t>5/1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3C0A5F-9CB5-A9D3-AD4E-991B72DABDD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76B226-9837-270F-C720-0B10437034F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BC218F-6715-284F-96B6-CB8B5DAF4E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3190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6EB35F43-F623-EB45-E1D5-85B02CE279FD}"/>
              </a:ext>
            </a:extLst>
          </p:cNvPr>
          <p:cNvGrpSpPr/>
          <p:nvPr/>
        </p:nvGrpSpPr>
        <p:grpSpPr>
          <a:xfrm>
            <a:off x="2255338" y="50469"/>
            <a:ext cx="7529740" cy="6497573"/>
            <a:chOff x="2952767" y="18450"/>
            <a:chExt cx="7926042" cy="6839550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1C89AE82-A404-5E19-79B7-B4DD6761F8D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/>
            <a:stretch/>
          </p:blipFill>
          <p:spPr>
            <a:xfrm>
              <a:off x="2952767" y="18450"/>
              <a:ext cx="6828762" cy="6839550"/>
            </a:xfrm>
            <a:prstGeom prst="rect">
              <a:avLst/>
            </a:prstGeom>
          </p:spPr>
        </p:pic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3BADDC5F-9FE3-F5DD-4ECD-8A6110A9E138}"/>
                </a:ext>
              </a:extLst>
            </p:cNvPr>
            <p:cNvCxnSpPr>
              <a:cxnSpLocks/>
            </p:cNvCxnSpPr>
            <p:nvPr/>
          </p:nvCxnSpPr>
          <p:spPr>
            <a:xfrm>
              <a:off x="7249319" y="149555"/>
              <a:ext cx="0" cy="21620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70BAE2C8-0D38-ACED-D766-1C6AE04B9B12}"/>
                </a:ext>
              </a:extLst>
            </p:cNvPr>
            <p:cNvCxnSpPr>
              <a:cxnSpLocks/>
            </p:cNvCxnSpPr>
            <p:nvPr/>
          </p:nvCxnSpPr>
          <p:spPr>
            <a:xfrm>
              <a:off x="8255794" y="437687"/>
              <a:ext cx="0" cy="21620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FFC5E6BB-9276-CB09-CE47-13B80BCB6AA5}"/>
                </a:ext>
              </a:extLst>
            </p:cNvPr>
            <p:cNvCxnSpPr>
              <a:cxnSpLocks/>
            </p:cNvCxnSpPr>
            <p:nvPr/>
          </p:nvCxnSpPr>
          <p:spPr>
            <a:xfrm>
              <a:off x="7854157" y="731521"/>
              <a:ext cx="0" cy="21620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>
              <a:extLst>
                <a:ext uri="{FF2B5EF4-FFF2-40B4-BE49-F238E27FC236}">
                  <a16:creationId xmlns:a16="http://schemas.microsoft.com/office/drawing/2014/main" id="{682CFBEA-8AFA-6F9F-73EC-6D57CE7A4D62}"/>
                </a:ext>
              </a:extLst>
            </p:cNvPr>
            <p:cNvCxnSpPr>
              <a:cxnSpLocks/>
            </p:cNvCxnSpPr>
            <p:nvPr/>
          </p:nvCxnSpPr>
          <p:spPr>
            <a:xfrm>
              <a:off x="8204994" y="1040143"/>
              <a:ext cx="0" cy="21620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1DA0E25E-89CE-2DFC-16F2-4649AA74EF44}"/>
                </a:ext>
              </a:extLst>
            </p:cNvPr>
            <p:cNvCxnSpPr>
              <a:cxnSpLocks/>
            </p:cNvCxnSpPr>
            <p:nvPr/>
          </p:nvCxnSpPr>
          <p:spPr>
            <a:xfrm>
              <a:off x="7590631" y="1354468"/>
              <a:ext cx="0" cy="21620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53C5C7F2-EF5A-DBF9-918A-65B0EAB42A54}"/>
                </a:ext>
              </a:extLst>
            </p:cNvPr>
            <p:cNvCxnSpPr>
              <a:cxnSpLocks/>
            </p:cNvCxnSpPr>
            <p:nvPr/>
          </p:nvCxnSpPr>
          <p:spPr>
            <a:xfrm>
              <a:off x="6851651" y="1654506"/>
              <a:ext cx="0" cy="21620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>
              <a:extLst>
                <a:ext uri="{FF2B5EF4-FFF2-40B4-BE49-F238E27FC236}">
                  <a16:creationId xmlns:a16="http://schemas.microsoft.com/office/drawing/2014/main" id="{B9BD1255-55FD-FBC3-B197-9D9BDBE0A80B}"/>
                </a:ext>
              </a:extLst>
            </p:cNvPr>
            <p:cNvCxnSpPr>
              <a:cxnSpLocks/>
            </p:cNvCxnSpPr>
            <p:nvPr/>
          </p:nvCxnSpPr>
          <p:spPr>
            <a:xfrm>
              <a:off x="7319962" y="1947400"/>
              <a:ext cx="0" cy="21620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>
              <a:extLst>
                <a:ext uri="{FF2B5EF4-FFF2-40B4-BE49-F238E27FC236}">
                  <a16:creationId xmlns:a16="http://schemas.microsoft.com/office/drawing/2014/main" id="{BFE73B49-E46D-44CB-FB23-826CFA45BA32}"/>
                </a:ext>
              </a:extLst>
            </p:cNvPr>
            <p:cNvCxnSpPr>
              <a:cxnSpLocks/>
            </p:cNvCxnSpPr>
            <p:nvPr/>
          </p:nvCxnSpPr>
          <p:spPr>
            <a:xfrm>
              <a:off x="6513512" y="2247437"/>
              <a:ext cx="0" cy="21620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Connector 40">
              <a:extLst>
                <a:ext uri="{FF2B5EF4-FFF2-40B4-BE49-F238E27FC236}">
                  <a16:creationId xmlns:a16="http://schemas.microsoft.com/office/drawing/2014/main" id="{55E66976-0D34-2397-2467-D2881649D853}"/>
                </a:ext>
              </a:extLst>
            </p:cNvPr>
            <p:cNvCxnSpPr>
              <a:cxnSpLocks/>
            </p:cNvCxnSpPr>
            <p:nvPr/>
          </p:nvCxnSpPr>
          <p:spPr>
            <a:xfrm>
              <a:off x="8502285" y="2544265"/>
              <a:ext cx="0" cy="21620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>
              <a:extLst>
                <a:ext uri="{FF2B5EF4-FFF2-40B4-BE49-F238E27FC236}">
                  <a16:creationId xmlns:a16="http://schemas.microsoft.com/office/drawing/2014/main" id="{A123889B-6B15-91F7-0078-9502A8DAE57F}"/>
                </a:ext>
              </a:extLst>
            </p:cNvPr>
            <p:cNvCxnSpPr>
              <a:cxnSpLocks/>
            </p:cNvCxnSpPr>
            <p:nvPr/>
          </p:nvCxnSpPr>
          <p:spPr>
            <a:xfrm>
              <a:off x="7866857" y="2854366"/>
              <a:ext cx="0" cy="21620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>
              <a:extLst>
                <a:ext uri="{FF2B5EF4-FFF2-40B4-BE49-F238E27FC236}">
                  <a16:creationId xmlns:a16="http://schemas.microsoft.com/office/drawing/2014/main" id="{3088D66E-4E6E-68CD-37A8-087A40DE2A35}"/>
                </a:ext>
              </a:extLst>
            </p:cNvPr>
            <p:cNvCxnSpPr>
              <a:cxnSpLocks/>
            </p:cNvCxnSpPr>
            <p:nvPr/>
          </p:nvCxnSpPr>
          <p:spPr>
            <a:xfrm>
              <a:off x="8732003" y="3141938"/>
              <a:ext cx="0" cy="21620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43">
              <a:extLst>
                <a:ext uri="{FF2B5EF4-FFF2-40B4-BE49-F238E27FC236}">
                  <a16:creationId xmlns:a16="http://schemas.microsoft.com/office/drawing/2014/main" id="{C1BDDD5D-7930-1628-FA22-07D12866D2E2}"/>
                </a:ext>
              </a:extLst>
            </p:cNvPr>
            <p:cNvCxnSpPr>
              <a:cxnSpLocks/>
            </p:cNvCxnSpPr>
            <p:nvPr/>
          </p:nvCxnSpPr>
          <p:spPr>
            <a:xfrm>
              <a:off x="8339077" y="3438225"/>
              <a:ext cx="0" cy="21620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Connector 44">
              <a:extLst>
                <a:ext uri="{FF2B5EF4-FFF2-40B4-BE49-F238E27FC236}">
                  <a16:creationId xmlns:a16="http://schemas.microsoft.com/office/drawing/2014/main" id="{0585A4B3-90B0-349A-6E3E-797729ADD89F}"/>
                </a:ext>
              </a:extLst>
            </p:cNvPr>
            <p:cNvCxnSpPr>
              <a:cxnSpLocks/>
            </p:cNvCxnSpPr>
            <p:nvPr/>
          </p:nvCxnSpPr>
          <p:spPr>
            <a:xfrm>
              <a:off x="8588880" y="3762140"/>
              <a:ext cx="0" cy="21620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>
              <a:extLst>
                <a:ext uri="{FF2B5EF4-FFF2-40B4-BE49-F238E27FC236}">
                  <a16:creationId xmlns:a16="http://schemas.microsoft.com/office/drawing/2014/main" id="{275A176D-1F3B-262B-924B-CAB412677AB6}"/>
                </a:ext>
              </a:extLst>
            </p:cNvPr>
            <p:cNvCxnSpPr>
              <a:cxnSpLocks/>
            </p:cNvCxnSpPr>
            <p:nvPr/>
          </p:nvCxnSpPr>
          <p:spPr>
            <a:xfrm>
              <a:off x="6513512" y="4049713"/>
              <a:ext cx="0" cy="21620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886C48DD-4467-37FB-AF37-AC7835AE0B15}"/>
                </a:ext>
              </a:extLst>
            </p:cNvPr>
            <p:cNvCxnSpPr>
              <a:cxnSpLocks/>
            </p:cNvCxnSpPr>
            <p:nvPr/>
          </p:nvCxnSpPr>
          <p:spPr>
            <a:xfrm>
              <a:off x="6316905" y="4343911"/>
              <a:ext cx="0" cy="21620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>
              <a:extLst>
                <a:ext uri="{FF2B5EF4-FFF2-40B4-BE49-F238E27FC236}">
                  <a16:creationId xmlns:a16="http://schemas.microsoft.com/office/drawing/2014/main" id="{12C2B39C-7D31-16E3-E7D0-D4AD0391C8D8}"/>
                </a:ext>
              </a:extLst>
            </p:cNvPr>
            <p:cNvCxnSpPr>
              <a:cxnSpLocks/>
            </p:cNvCxnSpPr>
            <p:nvPr/>
          </p:nvCxnSpPr>
          <p:spPr>
            <a:xfrm>
              <a:off x="6851577" y="4956160"/>
              <a:ext cx="0" cy="21620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Connector 48">
              <a:extLst>
                <a:ext uri="{FF2B5EF4-FFF2-40B4-BE49-F238E27FC236}">
                  <a16:creationId xmlns:a16="http://schemas.microsoft.com/office/drawing/2014/main" id="{BA032CE3-B331-D4A5-3F4F-0C526FB83F39}"/>
                </a:ext>
              </a:extLst>
            </p:cNvPr>
            <p:cNvCxnSpPr>
              <a:cxnSpLocks/>
            </p:cNvCxnSpPr>
            <p:nvPr/>
          </p:nvCxnSpPr>
          <p:spPr>
            <a:xfrm>
              <a:off x="6985036" y="5568412"/>
              <a:ext cx="0" cy="21620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Connector 49">
              <a:extLst>
                <a:ext uri="{FF2B5EF4-FFF2-40B4-BE49-F238E27FC236}">
                  <a16:creationId xmlns:a16="http://schemas.microsoft.com/office/drawing/2014/main" id="{FCE5D66C-E18B-F031-4529-268F2172DC7A}"/>
                </a:ext>
              </a:extLst>
            </p:cNvPr>
            <p:cNvCxnSpPr>
              <a:cxnSpLocks/>
            </p:cNvCxnSpPr>
            <p:nvPr/>
          </p:nvCxnSpPr>
          <p:spPr>
            <a:xfrm>
              <a:off x="6727281" y="5862610"/>
              <a:ext cx="0" cy="21620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Connector 50">
              <a:extLst>
                <a:ext uri="{FF2B5EF4-FFF2-40B4-BE49-F238E27FC236}">
                  <a16:creationId xmlns:a16="http://schemas.microsoft.com/office/drawing/2014/main" id="{4D772D52-F707-1AAF-E21F-1D09911B3B3A}"/>
                </a:ext>
              </a:extLst>
            </p:cNvPr>
            <p:cNvCxnSpPr>
              <a:cxnSpLocks/>
            </p:cNvCxnSpPr>
            <p:nvPr/>
          </p:nvCxnSpPr>
          <p:spPr>
            <a:xfrm>
              <a:off x="6988164" y="6164759"/>
              <a:ext cx="0" cy="21620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Connector 52">
              <a:extLst>
                <a:ext uri="{FF2B5EF4-FFF2-40B4-BE49-F238E27FC236}">
                  <a16:creationId xmlns:a16="http://schemas.microsoft.com/office/drawing/2014/main" id="{53ACB14F-C797-F774-879D-B07B8D3A6431}"/>
                </a:ext>
              </a:extLst>
            </p:cNvPr>
            <p:cNvCxnSpPr>
              <a:cxnSpLocks/>
            </p:cNvCxnSpPr>
            <p:nvPr/>
          </p:nvCxnSpPr>
          <p:spPr>
            <a:xfrm>
              <a:off x="9007980" y="4660578"/>
              <a:ext cx="0" cy="21620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Connector 53">
              <a:extLst>
                <a:ext uri="{FF2B5EF4-FFF2-40B4-BE49-F238E27FC236}">
                  <a16:creationId xmlns:a16="http://schemas.microsoft.com/office/drawing/2014/main" id="{84E745D2-217F-3D4D-E82F-1DE2453EC7D3}"/>
                </a:ext>
              </a:extLst>
            </p:cNvPr>
            <p:cNvCxnSpPr>
              <a:cxnSpLocks/>
            </p:cNvCxnSpPr>
            <p:nvPr/>
          </p:nvCxnSpPr>
          <p:spPr>
            <a:xfrm>
              <a:off x="9007980" y="4689154"/>
              <a:ext cx="0" cy="21620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Straight Connector 54">
              <a:extLst>
                <a:ext uri="{FF2B5EF4-FFF2-40B4-BE49-F238E27FC236}">
                  <a16:creationId xmlns:a16="http://schemas.microsoft.com/office/drawing/2014/main" id="{D92A8696-F774-46A0-7C7D-49FEBA2EE6D8}"/>
                </a:ext>
              </a:extLst>
            </p:cNvPr>
            <p:cNvCxnSpPr>
              <a:cxnSpLocks/>
            </p:cNvCxnSpPr>
            <p:nvPr/>
          </p:nvCxnSpPr>
          <p:spPr>
            <a:xfrm>
              <a:off x="9000836" y="5270179"/>
              <a:ext cx="0" cy="21620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56" name="Picture 55">
              <a:extLst>
                <a:ext uri="{FF2B5EF4-FFF2-40B4-BE49-F238E27FC236}">
                  <a16:creationId xmlns:a16="http://schemas.microsoft.com/office/drawing/2014/main" id="{D06BA0F7-FE0D-6E1F-AD03-0AB149B41B3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9781529" y="2954523"/>
              <a:ext cx="1097280" cy="731520"/>
            </a:xfrm>
            <a:prstGeom prst="rect">
              <a:avLst/>
            </a:prstGeom>
          </p:spPr>
        </p:pic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78AECDD4-382A-889C-3D56-670E6E3408A8}"/>
              </a:ext>
            </a:extLst>
          </p:cNvPr>
          <p:cNvSpPr txBox="1"/>
          <p:nvPr/>
        </p:nvSpPr>
        <p:spPr>
          <a:xfrm>
            <a:off x="8988799" y="5510084"/>
            <a:ext cx="254581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*p&lt;0.05</a:t>
            </a:r>
          </a:p>
          <a:p>
            <a:r>
              <a:rPr lang="en-US" sz="800" dirty="0"/>
              <a:t>**0.01</a:t>
            </a:r>
          </a:p>
          <a:p>
            <a:r>
              <a:rPr lang="en-US" sz="800" dirty="0"/>
              <a:t>***p&lt;0.001</a:t>
            </a:r>
          </a:p>
          <a:p>
            <a:r>
              <a:rPr lang="en-US" sz="800" dirty="0"/>
              <a:t>****p&lt;0.000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7FA0514-FF64-935B-2B2C-2EDFEE81CED8}"/>
              </a:ext>
            </a:extLst>
          </p:cNvPr>
          <p:cNvSpPr txBox="1"/>
          <p:nvPr/>
        </p:nvSpPr>
        <p:spPr>
          <a:xfrm>
            <a:off x="2363552" y="6596390"/>
            <a:ext cx="9096214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dirty="0"/>
              <a:t>Supplementary Figure 1. Evaluation of histopathologic characteristics in non-lesional skin (purple bars) and lesional skin (teal bars) of patients with PN (n</a:t>
            </a:r>
            <a:r>
              <a:rPr lang="en-US" sz="1100"/>
              <a:t>=53). 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23369595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C260F567E83CA4B9516D13471114631" ma:contentTypeVersion="17" ma:contentTypeDescription="Create a new document." ma:contentTypeScope="" ma:versionID="c1fbd6289b629488467ef37102a322cb">
  <xsd:schema xmlns:xsd="http://www.w3.org/2001/XMLSchema" xmlns:xs="http://www.w3.org/2001/XMLSchema" xmlns:p="http://schemas.microsoft.com/office/2006/metadata/properties" xmlns:ns2="48e0ab68-5cae-4c34-92ae-33d58f8675e5" xmlns:ns3="a25aac7e-bdeb-479a-95a9-91489ea9020e" targetNamespace="http://schemas.microsoft.com/office/2006/metadata/properties" ma:root="true" ma:fieldsID="1cb45fd8ad8bae3faad346a218767fa8" ns2:_="" ns3:_="">
    <xsd:import namespace="48e0ab68-5cae-4c34-92ae-33d58f8675e5"/>
    <xsd:import namespace="a25aac7e-bdeb-479a-95a9-91489ea9020e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DateTaken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2:MediaServiceOCR" minOccurs="0"/>
                <xsd:element ref="ns3:SharedWithUsers" minOccurs="0"/>
                <xsd:element ref="ns3:SharedWithDetails" minOccurs="0"/>
                <xsd:element ref="ns2:MediaLengthInSeconds" minOccurs="0"/>
                <xsd:element ref="ns2:lcf76f155ced4ddcb4097134ff3c332f" minOccurs="0"/>
                <xsd:element ref="ns3:TaxCatchAll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8e0ab68-5cae-4c34-92ae-33d58f8675e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LengthInSeconds" ma:index="19" nillable="true" ma:displayName="Length (seconds)" ma:internalName="MediaLengthInSeconds" ma:readOnly="true">
      <xsd:simpleType>
        <xsd:restriction base="dms:Unknown"/>
      </xsd:simpleType>
    </xsd:element>
    <xsd:element name="lcf76f155ced4ddcb4097134ff3c332f" ma:index="21" nillable="true" ma:taxonomy="true" ma:internalName="lcf76f155ced4ddcb4097134ff3c332f" ma:taxonomyFieldName="MediaServiceImageTags" ma:displayName="Image Tags" ma:readOnly="false" ma:fieldId="{5cf76f15-5ced-4ddc-b409-7134ff3c332f}" ma:taxonomyMulti="true" ma:sspId="c2180d27-daa2-489f-be1a-46b0e90a7ab3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23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4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25aac7e-bdeb-479a-95a9-91489ea9020e" elementFormDefault="qualified">
    <xsd:import namespace="http://schemas.microsoft.com/office/2006/documentManagement/types"/>
    <xsd:import namespace="http://schemas.microsoft.com/office/infopath/2007/PartnerControls"/>
    <xsd:element name="SharedWithUsers" ma:index="1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2" nillable="true" ma:displayName="Taxonomy Catch All Column" ma:hidden="true" ma:list="{7f3278fd-a32d-484e-b5f2-429d4195481e}" ma:internalName="TaxCatchAll" ma:showField="CatchAllData" ma:web="a25aac7e-bdeb-479a-95a9-91489ea9020e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48e0ab68-5cae-4c34-92ae-33d58f8675e5">
      <Terms xmlns="http://schemas.microsoft.com/office/infopath/2007/PartnerControls"/>
    </lcf76f155ced4ddcb4097134ff3c332f>
    <TaxCatchAll xmlns="a25aac7e-bdeb-479a-95a9-91489ea9020e" xsi:nil="true"/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F42210B0-F330-4371-B02A-3C9D2AF09253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8e0ab68-5cae-4c34-92ae-33d58f8675e5"/>
    <ds:schemaRef ds:uri="a25aac7e-bdeb-479a-95a9-91489ea9020e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08465EEC-34D7-4DC8-99A8-73BC6BC115F8}">
  <ds:schemaRefs>
    <ds:schemaRef ds:uri="http://schemas.microsoft.com/office/2006/metadata/properties"/>
    <ds:schemaRef ds:uri="http://schemas.microsoft.com/office/infopath/2007/PartnerControls"/>
    <ds:schemaRef ds:uri="48e0ab68-5cae-4c34-92ae-33d58f8675e5"/>
    <ds:schemaRef ds:uri="a25aac7e-bdeb-479a-95a9-91489ea9020e"/>
  </ds:schemaRefs>
</ds:datastoreItem>
</file>

<file path=customXml/itemProps3.xml><?xml version="1.0" encoding="utf-8"?>
<ds:datastoreItem xmlns:ds="http://schemas.openxmlformats.org/officeDocument/2006/customXml" ds:itemID="{61D3FC21-A26F-42C4-BE13-AAD0A1892658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6241</TotalTime>
  <Words>45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deline Kim</dc:creator>
  <cp:lastModifiedBy>JoAnn Clair</cp:lastModifiedBy>
  <cp:revision>93</cp:revision>
  <dcterms:created xsi:type="dcterms:W3CDTF">2023-08-23T13:59:38Z</dcterms:created>
  <dcterms:modified xsi:type="dcterms:W3CDTF">2025-05-15T14:41:5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C260F567E83CA4B9516D13471114631</vt:lpwstr>
  </property>
  <property fmtid="{D5CDD505-2E9C-101B-9397-08002B2CF9AE}" pid="3" name="MediaServiceImageTags">
    <vt:lpwstr/>
  </property>
</Properties>
</file>